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  <p:sldId id="260" r:id="rId4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1524" y="-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E:\1. 课题\2. 文章相关1\6.机制\6A SB cyto nuclear\j h smad24-1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 rot="153484">
            <a:off x="948711" y="48798"/>
            <a:ext cx="7046149" cy="4886311"/>
          </a:xfrm>
          <a:prstGeom prst="rect">
            <a:avLst/>
          </a:prstGeom>
          <a:noFill/>
        </p:spPr>
      </p:pic>
      <p:sp>
        <p:nvSpPr>
          <p:cNvPr id="3" name="矩形 2"/>
          <p:cNvSpPr/>
          <p:nvPr/>
        </p:nvSpPr>
        <p:spPr>
          <a:xfrm>
            <a:off x="1493912" y="1175026"/>
            <a:ext cx="516632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 err="1" smtClean="0"/>
              <a:t>shNT</a:t>
            </a:r>
            <a:r>
              <a:rPr lang="en-US" altLang="zh-CN" dirty="0" smtClean="0"/>
              <a:t>               +     -     +     -             +     -     +     -</a:t>
            </a:r>
          </a:p>
          <a:p>
            <a:r>
              <a:rPr lang="en-US" altLang="zh-CN" dirty="0" smtClean="0"/>
              <a:t>shRanBP3#1  -     +     -     +             -     +     -     +</a:t>
            </a:r>
          </a:p>
          <a:p>
            <a:r>
              <a:rPr lang="en-US" altLang="zh-CN" dirty="0" smtClean="0"/>
              <a:t>SB431542       -     -     +     +             -     -     +     + </a:t>
            </a:r>
            <a:endParaRPr lang="zh-CN" alt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6228184" y="2002247"/>
            <a:ext cx="21237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/>
              <a:t>SMAD2/3</a:t>
            </a:r>
            <a:endParaRPr lang="zh-CN" altLang="en-US" sz="20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2555776" y="634095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K562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8" name="直接连接符 7"/>
          <p:cNvCxnSpPr/>
          <p:nvPr/>
        </p:nvCxnSpPr>
        <p:spPr>
          <a:xfrm>
            <a:off x="2771800" y="1066143"/>
            <a:ext cx="1368152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4572000" y="634095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K562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0" name="直接连接符 9"/>
          <p:cNvCxnSpPr/>
          <p:nvPr/>
        </p:nvCxnSpPr>
        <p:spPr>
          <a:xfrm>
            <a:off x="4644008" y="1066143"/>
            <a:ext cx="1293894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" name="TextBox 4"/>
          <p:cNvSpPr txBox="1"/>
          <p:nvPr/>
        </p:nvSpPr>
        <p:spPr>
          <a:xfrm>
            <a:off x="4572000" y="2636912"/>
            <a:ext cx="15841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/>
              <a:t>nuclear</a:t>
            </a:r>
            <a:endParaRPr lang="zh-CN" alt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2555776" y="2564904"/>
            <a:ext cx="15841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/>
              <a:t>Cytoplasm</a:t>
            </a:r>
            <a:endParaRPr lang="zh-CN" altLang="en-US" sz="2000" b="1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E:\1. 课题\2. 文章相关1\6.机制\6A SB cyto nuclear\H3 1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08000" y="381000"/>
            <a:ext cx="8128000" cy="6096000"/>
          </a:xfrm>
          <a:prstGeom prst="rect">
            <a:avLst/>
          </a:prstGeom>
          <a:noFill/>
        </p:spPr>
      </p:pic>
      <p:sp>
        <p:nvSpPr>
          <p:cNvPr id="3" name="矩形 2"/>
          <p:cNvSpPr/>
          <p:nvPr/>
        </p:nvSpPr>
        <p:spPr>
          <a:xfrm>
            <a:off x="1493912" y="1175026"/>
            <a:ext cx="516632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 err="1" smtClean="0"/>
              <a:t>shNT</a:t>
            </a:r>
            <a:r>
              <a:rPr lang="en-US" altLang="zh-CN" dirty="0" smtClean="0"/>
              <a:t>               +     -     +     -             +     -     +     -</a:t>
            </a:r>
          </a:p>
          <a:p>
            <a:r>
              <a:rPr lang="en-US" altLang="zh-CN" dirty="0" smtClean="0"/>
              <a:t>shRanBP3#1  -     +     -     +             -     +     -     +</a:t>
            </a:r>
          </a:p>
          <a:p>
            <a:r>
              <a:rPr lang="en-US" altLang="zh-CN" dirty="0" smtClean="0"/>
              <a:t>SB431542       -     -     +     +             -     -     +     + </a:t>
            </a:r>
            <a:endParaRPr lang="zh-CN" alt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2555776" y="634095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K562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6" name="直接连接符 5"/>
          <p:cNvCxnSpPr/>
          <p:nvPr/>
        </p:nvCxnSpPr>
        <p:spPr>
          <a:xfrm>
            <a:off x="2771800" y="1066143"/>
            <a:ext cx="1368152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4572000" y="634095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K562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8" name="直接连接符 7"/>
          <p:cNvCxnSpPr/>
          <p:nvPr/>
        </p:nvCxnSpPr>
        <p:spPr>
          <a:xfrm>
            <a:off x="4644008" y="1066143"/>
            <a:ext cx="1293894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4572000" y="3429000"/>
            <a:ext cx="15841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/>
              <a:t>nuclear</a:t>
            </a:r>
            <a:endParaRPr lang="zh-CN" altLang="en-US" sz="20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2267744" y="3356992"/>
            <a:ext cx="15841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/>
              <a:t>Cytoplasm</a:t>
            </a:r>
            <a:endParaRPr lang="zh-CN" altLang="en-US" sz="20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6516216" y="2636912"/>
            <a:ext cx="15841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/>
              <a:t>H3</a:t>
            </a:r>
            <a:endParaRPr lang="zh-CN" altLang="en-US" sz="2000" b="1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E:\1. 课题\2. 文章相关1\6.机制\6A SB cyto nuclear\ACTIN2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 rot="1886155">
            <a:off x="508000" y="381000"/>
            <a:ext cx="8128000" cy="6096000"/>
          </a:xfrm>
          <a:prstGeom prst="rect">
            <a:avLst/>
          </a:prstGeom>
          <a:noFill/>
        </p:spPr>
      </p:pic>
      <p:sp>
        <p:nvSpPr>
          <p:cNvPr id="3" name="矩形 2"/>
          <p:cNvSpPr/>
          <p:nvPr/>
        </p:nvSpPr>
        <p:spPr>
          <a:xfrm>
            <a:off x="1493912" y="1175026"/>
            <a:ext cx="516632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 err="1" smtClean="0"/>
              <a:t>shNT</a:t>
            </a:r>
            <a:r>
              <a:rPr lang="en-US" altLang="zh-CN" dirty="0" smtClean="0"/>
              <a:t>               +     -     +     -             +     -     +     -</a:t>
            </a:r>
          </a:p>
          <a:p>
            <a:r>
              <a:rPr lang="en-US" altLang="zh-CN" dirty="0" smtClean="0"/>
              <a:t>shRanBP3#1  -     +     -     +             -     +     -     +</a:t>
            </a:r>
          </a:p>
          <a:p>
            <a:r>
              <a:rPr lang="en-US" altLang="zh-CN" dirty="0" smtClean="0"/>
              <a:t>SB431542       -     -     +     +             -     -     +     + </a:t>
            </a:r>
            <a:endParaRPr lang="zh-CN" alt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2555776" y="634095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K562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6" name="直接连接符 5"/>
          <p:cNvCxnSpPr/>
          <p:nvPr/>
        </p:nvCxnSpPr>
        <p:spPr>
          <a:xfrm>
            <a:off x="2771800" y="1066143"/>
            <a:ext cx="1368152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4572000" y="634095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K562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8" name="直接连接符 7"/>
          <p:cNvCxnSpPr/>
          <p:nvPr/>
        </p:nvCxnSpPr>
        <p:spPr>
          <a:xfrm>
            <a:off x="4644008" y="1066143"/>
            <a:ext cx="1293894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5004048" y="5195199"/>
            <a:ext cx="15841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/>
              <a:t>nuclear</a:t>
            </a:r>
            <a:endParaRPr lang="zh-CN" altLang="en-US" sz="20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3131840" y="5195199"/>
            <a:ext cx="15841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/>
              <a:t>Cytoplasm</a:t>
            </a:r>
            <a:endParaRPr lang="zh-CN" altLang="en-US" sz="20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6876256" y="4475119"/>
            <a:ext cx="15841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/>
              <a:t>ACTIN</a:t>
            </a:r>
            <a:endParaRPr lang="zh-CN" altLang="en-US" sz="2000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</TotalTime>
  <Words>96</Words>
  <Application>Microsoft Office PowerPoint</Application>
  <PresentationFormat>全屏显示(4:3)</PresentationFormat>
  <Paragraphs>24</Paragraphs>
  <Slides>3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4" baseType="lpstr">
      <vt:lpstr>Office 主题</vt:lpstr>
      <vt:lpstr>幻灯片 1</vt:lpstr>
      <vt:lpstr>幻灯片 2</vt:lpstr>
      <vt:lpstr>幻灯片 3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istrator</dc:creator>
  <cp:lastModifiedBy>LIQIAN</cp:lastModifiedBy>
  <cp:revision>4</cp:revision>
  <dcterms:created xsi:type="dcterms:W3CDTF">2021-05-07T09:48:26Z</dcterms:created>
  <dcterms:modified xsi:type="dcterms:W3CDTF">2021-05-10T15:32:35Z</dcterms:modified>
</cp:coreProperties>
</file>